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96" r:id="rId1"/>
  </p:sldMasterIdLst>
  <p:sldIdLst>
    <p:sldId id="259" r:id="rId2"/>
  </p:sldIdLst>
  <p:sldSz cx="6858000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86" d="100"/>
          <a:sy n="86" d="100"/>
        </p:scale>
        <p:origin x="127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346836"/>
            <a:ext cx="5829300" cy="286512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322446"/>
            <a:ext cx="5143500" cy="1986914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00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240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38150"/>
            <a:ext cx="1478756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38150"/>
            <a:ext cx="4350544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04397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630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051688"/>
            <a:ext cx="5915025" cy="3423284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507358"/>
            <a:ext cx="5915025" cy="180022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6100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190750"/>
            <a:ext cx="29146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190750"/>
            <a:ext cx="29146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395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38152"/>
            <a:ext cx="5915025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017396"/>
            <a:ext cx="2901255" cy="98869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006090"/>
            <a:ext cx="2901255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017396"/>
            <a:ext cx="2915543" cy="98869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006090"/>
            <a:ext cx="2915543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3641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21033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770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48640"/>
            <a:ext cx="2211884" cy="19202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184912"/>
            <a:ext cx="3471863" cy="584835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68880"/>
            <a:ext cx="2211884" cy="457390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5527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48640"/>
            <a:ext cx="2211884" cy="19202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184912"/>
            <a:ext cx="3471863" cy="584835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68880"/>
            <a:ext cx="2211884" cy="457390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47826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38152"/>
            <a:ext cx="5915025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190750"/>
            <a:ext cx="5915025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7627622"/>
            <a:ext cx="154305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7627622"/>
            <a:ext cx="2314575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7627622"/>
            <a:ext cx="154305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4890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5829144-DF0E-55AA-482D-BD710EB994E0}"/>
              </a:ext>
            </a:extLst>
          </p:cNvPr>
          <p:cNvSpPr txBox="1"/>
          <p:nvPr/>
        </p:nvSpPr>
        <p:spPr>
          <a:xfrm>
            <a:off x="239197" y="5739382"/>
            <a:ext cx="6379605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. Figure 2.</a:t>
            </a:r>
            <a:r>
              <a:rPr lang="en-US" sz="14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stern blot analysis showing the immunoreactivity of (A) CA I isoform (1.4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mol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with all developed monoclonal antibody (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clones (crude hybridoma supernatants) </a:t>
            </a:r>
            <a:r>
              <a:rPr lang="en-US" sz="14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 lanes: (1) 1A6 </a:t>
            </a:r>
            <a:r>
              <a:rPr lang="en-US" sz="14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US" sz="14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(2) 2A5 </a:t>
            </a:r>
            <a:r>
              <a:rPr lang="en-US" sz="14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US" sz="14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(3) 2B8 </a:t>
            </a:r>
            <a:r>
              <a:rPr lang="en-US" sz="14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US" sz="14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(4) 6B10 </a:t>
            </a:r>
            <a:r>
              <a:rPr lang="en-US" sz="14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US" sz="14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(5) 7B8 </a:t>
            </a:r>
            <a:r>
              <a:rPr lang="en-US" sz="14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US" sz="14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(6) 2D10 </a:t>
            </a:r>
            <a:r>
              <a:rPr lang="en-US" sz="14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US" sz="14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(7) 6D9 </a:t>
            </a:r>
            <a:r>
              <a:rPr lang="en-US" sz="14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US" sz="14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(8) 2G9 </a:t>
            </a:r>
            <a:r>
              <a:rPr lang="en-US" sz="14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US" sz="14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(9) 7H10 </a:t>
            </a:r>
            <a:r>
              <a:rPr lang="en-US" sz="14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US" sz="14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(10) whole mouse serum, dilution: (1-9) 5x, (10) 200x; 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B) CA isoforms (1.4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mol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with purified 2B8 monoclonal antibody (stock solution 1 mg/ml)</a:t>
            </a:r>
            <a:r>
              <a:rPr lang="en-US" sz="14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dilution of 2B8 antibody 100,000x - lanes: (1) CA I, (2) CA II, (3) CA VA, (4) CA VB, (5) CA IX, (6) CA XII.</a:t>
            </a:r>
            <a:endParaRPr lang="en-US" sz="14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5" name="Skupina 1">
            <a:extLst>
              <a:ext uri="{FF2B5EF4-FFF2-40B4-BE49-F238E27FC236}">
                <a16:creationId xmlns:a16="http://schemas.microsoft.com/office/drawing/2014/main" id="{FF5628BE-CB3E-8638-4D48-BE111B164054}"/>
              </a:ext>
            </a:extLst>
          </p:cNvPr>
          <p:cNvGrpSpPr/>
          <p:nvPr/>
        </p:nvGrpSpPr>
        <p:grpSpPr>
          <a:xfrm>
            <a:off x="892776" y="432308"/>
            <a:ext cx="4471312" cy="4583032"/>
            <a:chOff x="892776" y="432308"/>
            <a:chExt cx="4471312" cy="4583032"/>
          </a:xfrm>
        </p:grpSpPr>
        <p:pic>
          <p:nvPicPr>
            <p:cNvPr id="16" name="Picture 2">
              <a:extLst>
                <a:ext uri="{FF2B5EF4-FFF2-40B4-BE49-F238E27FC236}">
                  <a16:creationId xmlns:a16="http://schemas.microsoft.com/office/drawing/2014/main" id="{1B4A3925-DFDE-5FB1-0BB8-C35CE8BC096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056" t="18443" r="1739" b="36458"/>
            <a:stretch/>
          </p:blipFill>
          <p:spPr bwMode="auto">
            <a:xfrm>
              <a:off x="2051720" y="3131676"/>
              <a:ext cx="2684920" cy="1883664"/>
            </a:xfrm>
            <a:prstGeom prst="rect">
              <a:avLst/>
            </a:prstGeom>
            <a:noFill/>
            <a:ln w="19050">
              <a:solidFill>
                <a:schemeClr val="bg1">
                  <a:lumMod val="50000"/>
                </a:schemeClr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7" name="TextovéPole 3">
              <a:extLst>
                <a:ext uri="{FF2B5EF4-FFF2-40B4-BE49-F238E27FC236}">
                  <a16:creationId xmlns:a16="http://schemas.microsoft.com/office/drawing/2014/main" id="{F8E1E7CE-010C-A363-5FE8-F6C093AC867D}"/>
                </a:ext>
              </a:extLst>
            </p:cNvPr>
            <p:cNvSpPr txBox="1"/>
            <p:nvPr/>
          </p:nvSpPr>
          <p:spPr>
            <a:xfrm>
              <a:off x="1979712" y="4597799"/>
              <a:ext cx="32403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dirty="0"/>
                <a:t>    </a:t>
              </a:r>
              <a:r>
                <a:rPr lang="cs-CZ" sz="1200" b="1" dirty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MM             1       2       3      4      5      6</a:t>
              </a:r>
            </a:p>
          </p:txBody>
        </p:sp>
        <p:sp>
          <p:nvSpPr>
            <p:cNvPr id="18" name="TextovéPole 5">
              <a:extLst>
                <a:ext uri="{FF2B5EF4-FFF2-40B4-BE49-F238E27FC236}">
                  <a16:creationId xmlns:a16="http://schemas.microsoft.com/office/drawing/2014/main" id="{B8E0F623-8E50-BF4D-2EBA-F71C069B45E5}"/>
                </a:ext>
              </a:extLst>
            </p:cNvPr>
            <p:cNvSpPr txBox="1"/>
            <p:nvPr/>
          </p:nvSpPr>
          <p:spPr>
            <a:xfrm>
              <a:off x="892776" y="2780928"/>
              <a:ext cx="345638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dirty="0"/>
                <a:t>                    </a:t>
              </a:r>
              <a:r>
                <a:rPr lang="cs-CZ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19" name="TextovéPole 10">
              <a:extLst>
                <a:ext uri="{FF2B5EF4-FFF2-40B4-BE49-F238E27FC236}">
                  <a16:creationId xmlns:a16="http://schemas.microsoft.com/office/drawing/2014/main" id="{388C2B6F-BD9A-07D3-8A38-20DDEC54ACE4}"/>
                </a:ext>
              </a:extLst>
            </p:cNvPr>
            <p:cNvSpPr txBox="1"/>
            <p:nvPr/>
          </p:nvSpPr>
          <p:spPr>
            <a:xfrm>
              <a:off x="1979712" y="3966612"/>
              <a:ext cx="7200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dirty="0"/>
                <a:t>    </a:t>
              </a:r>
              <a:r>
                <a:rPr lang="cs-CZ" sz="900" b="1" dirty="0"/>
                <a:t>25 </a:t>
              </a:r>
              <a:r>
                <a:rPr lang="cs-CZ" sz="900" b="1" dirty="0" err="1"/>
                <a:t>kDa</a:t>
              </a:r>
              <a:endParaRPr lang="cs-CZ" sz="900" b="1" dirty="0"/>
            </a:p>
          </p:txBody>
        </p:sp>
        <p:sp>
          <p:nvSpPr>
            <p:cNvPr id="20" name="TextovéPole 12">
              <a:extLst>
                <a:ext uri="{FF2B5EF4-FFF2-40B4-BE49-F238E27FC236}">
                  <a16:creationId xmlns:a16="http://schemas.microsoft.com/office/drawing/2014/main" id="{4DF5517B-B3F0-23FB-E6A4-878B832629C1}"/>
                </a:ext>
              </a:extLst>
            </p:cNvPr>
            <p:cNvSpPr txBox="1"/>
            <p:nvPr/>
          </p:nvSpPr>
          <p:spPr>
            <a:xfrm>
              <a:off x="1979712" y="3556144"/>
              <a:ext cx="7200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dirty="0"/>
                <a:t>    </a:t>
              </a:r>
              <a:r>
                <a:rPr lang="cs-CZ" sz="900" b="1" dirty="0"/>
                <a:t>37 </a:t>
              </a:r>
              <a:r>
                <a:rPr lang="cs-CZ" sz="900" b="1" dirty="0" err="1"/>
                <a:t>kDa</a:t>
              </a:r>
              <a:endParaRPr lang="cs-CZ" sz="900" b="1" dirty="0"/>
            </a:p>
          </p:txBody>
        </p:sp>
        <p:sp>
          <p:nvSpPr>
            <p:cNvPr id="21" name="TextovéPole 15">
              <a:extLst>
                <a:ext uri="{FF2B5EF4-FFF2-40B4-BE49-F238E27FC236}">
                  <a16:creationId xmlns:a16="http://schemas.microsoft.com/office/drawing/2014/main" id="{6765D364-6054-497B-F845-D263B918F925}"/>
                </a:ext>
              </a:extLst>
            </p:cNvPr>
            <p:cNvSpPr txBox="1"/>
            <p:nvPr/>
          </p:nvSpPr>
          <p:spPr>
            <a:xfrm>
              <a:off x="1979712" y="3212976"/>
              <a:ext cx="7200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tabLst>
                  <a:tab pos="182563" algn="l"/>
                  <a:tab pos="265113" algn="l"/>
                </a:tabLst>
              </a:pPr>
              <a:r>
                <a:rPr lang="cs-CZ" dirty="0"/>
                <a:t>    </a:t>
              </a:r>
              <a:r>
                <a:rPr lang="cs-CZ" sz="900" b="1" dirty="0"/>
                <a:t>50 </a:t>
              </a:r>
              <a:r>
                <a:rPr lang="cs-CZ" sz="900" b="1" dirty="0" err="1"/>
                <a:t>kDa</a:t>
              </a:r>
              <a:endParaRPr lang="cs-CZ" sz="900" b="1" dirty="0"/>
            </a:p>
          </p:txBody>
        </p:sp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3822F969-E860-76F6-E82F-EAF180080FD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37" t="22060" r="11944" b="38970"/>
            <a:stretch/>
          </p:blipFill>
          <p:spPr bwMode="auto">
            <a:xfrm>
              <a:off x="1473425" y="793373"/>
              <a:ext cx="3772911" cy="2061699"/>
            </a:xfrm>
            <a:prstGeom prst="rect">
              <a:avLst/>
            </a:prstGeom>
            <a:noFill/>
            <a:ln w="19050">
              <a:solidFill>
                <a:schemeClr val="bg1">
                  <a:lumMod val="50000"/>
                </a:schemeClr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3" name="TextovéPole 16">
              <a:extLst>
                <a:ext uri="{FF2B5EF4-FFF2-40B4-BE49-F238E27FC236}">
                  <a16:creationId xmlns:a16="http://schemas.microsoft.com/office/drawing/2014/main" id="{675A332C-072D-20C8-9129-CE9C6FE48E22}"/>
                </a:ext>
              </a:extLst>
            </p:cNvPr>
            <p:cNvSpPr txBox="1"/>
            <p:nvPr/>
          </p:nvSpPr>
          <p:spPr>
            <a:xfrm>
              <a:off x="899592" y="432308"/>
              <a:ext cx="446449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dirty="0"/>
                <a:t>         </a:t>
              </a:r>
              <a:r>
                <a:rPr lang="cs-CZ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24" name="TextovéPole 17">
              <a:extLst>
                <a:ext uri="{FF2B5EF4-FFF2-40B4-BE49-F238E27FC236}">
                  <a16:creationId xmlns:a16="http://schemas.microsoft.com/office/drawing/2014/main" id="{54EFB9F1-2CA8-5025-7199-0177852542B7}"/>
                </a:ext>
              </a:extLst>
            </p:cNvPr>
            <p:cNvSpPr txBox="1"/>
            <p:nvPr/>
          </p:nvSpPr>
          <p:spPr>
            <a:xfrm>
              <a:off x="1483720" y="2555612"/>
              <a:ext cx="38083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dirty="0"/>
                <a:t>    </a:t>
              </a:r>
              <a:r>
                <a:rPr lang="cs-CZ" sz="1200" b="1" dirty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MM             1      2     3      4      5       6      7     8      9    10</a:t>
              </a:r>
            </a:p>
          </p:txBody>
        </p:sp>
        <p:sp>
          <p:nvSpPr>
            <p:cNvPr id="25" name="TextovéPole 18">
              <a:extLst>
                <a:ext uri="{FF2B5EF4-FFF2-40B4-BE49-F238E27FC236}">
                  <a16:creationId xmlns:a16="http://schemas.microsoft.com/office/drawing/2014/main" id="{4706B2B9-61C6-15CF-7BC6-E8C3CAE1D6A4}"/>
                </a:ext>
              </a:extLst>
            </p:cNvPr>
            <p:cNvSpPr txBox="1"/>
            <p:nvPr/>
          </p:nvSpPr>
          <p:spPr>
            <a:xfrm>
              <a:off x="1410464" y="1979548"/>
              <a:ext cx="7200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dirty="0"/>
                <a:t>    </a:t>
              </a:r>
              <a:r>
                <a:rPr lang="cs-CZ" sz="900" b="1" dirty="0"/>
                <a:t>25 </a:t>
              </a:r>
              <a:r>
                <a:rPr lang="cs-CZ" sz="900" b="1" dirty="0" err="1"/>
                <a:t>kDa</a:t>
              </a:r>
              <a:endParaRPr lang="cs-CZ" sz="900" b="1" dirty="0"/>
            </a:p>
          </p:txBody>
        </p:sp>
        <p:sp>
          <p:nvSpPr>
            <p:cNvPr id="26" name="TextovéPole 19">
              <a:extLst>
                <a:ext uri="{FF2B5EF4-FFF2-40B4-BE49-F238E27FC236}">
                  <a16:creationId xmlns:a16="http://schemas.microsoft.com/office/drawing/2014/main" id="{452F3C3F-0C20-9AF0-339C-2B8C30050E83}"/>
                </a:ext>
              </a:extLst>
            </p:cNvPr>
            <p:cNvSpPr txBox="1"/>
            <p:nvPr/>
          </p:nvSpPr>
          <p:spPr>
            <a:xfrm>
              <a:off x="1410464" y="1569080"/>
              <a:ext cx="7200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dirty="0"/>
                <a:t>    </a:t>
              </a:r>
              <a:r>
                <a:rPr lang="cs-CZ" sz="900" b="1" dirty="0"/>
                <a:t>37 </a:t>
              </a:r>
              <a:r>
                <a:rPr lang="cs-CZ" sz="900" b="1" dirty="0" err="1"/>
                <a:t>kDa</a:t>
              </a:r>
              <a:endParaRPr lang="cs-CZ" sz="900" b="1" dirty="0"/>
            </a:p>
          </p:txBody>
        </p:sp>
        <p:sp>
          <p:nvSpPr>
            <p:cNvPr id="27" name="TextovéPole 20">
              <a:extLst>
                <a:ext uri="{FF2B5EF4-FFF2-40B4-BE49-F238E27FC236}">
                  <a16:creationId xmlns:a16="http://schemas.microsoft.com/office/drawing/2014/main" id="{666B8D3C-F706-95DE-EAAC-CA0B8E3239ED}"/>
                </a:ext>
              </a:extLst>
            </p:cNvPr>
            <p:cNvSpPr txBox="1"/>
            <p:nvPr/>
          </p:nvSpPr>
          <p:spPr>
            <a:xfrm>
              <a:off x="1425400" y="755412"/>
              <a:ext cx="7200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tabLst>
                  <a:tab pos="182563" algn="l"/>
                  <a:tab pos="265113" algn="l"/>
                </a:tabLst>
              </a:pPr>
              <a:r>
                <a:rPr lang="cs-CZ" dirty="0"/>
                <a:t>    </a:t>
              </a:r>
              <a:r>
                <a:rPr lang="cs-CZ" sz="900" b="1" dirty="0"/>
                <a:t>50 </a:t>
              </a:r>
              <a:r>
                <a:rPr lang="cs-CZ" sz="900" b="1" dirty="0" err="1"/>
                <a:t>kDa</a:t>
              </a:r>
              <a:endParaRPr lang="cs-CZ" sz="9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7126800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264</TotalTime>
  <Words>220</Words>
  <Application>Microsoft Office PowerPoint</Application>
  <PresentationFormat>Custom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do Skultety</dc:creator>
  <cp:lastModifiedBy>Ludovit Skultety</cp:lastModifiedBy>
  <cp:revision>20</cp:revision>
  <dcterms:created xsi:type="dcterms:W3CDTF">2023-04-23T08:26:50Z</dcterms:created>
  <dcterms:modified xsi:type="dcterms:W3CDTF">2024-12-04T14:57:10Z</dcterms:modified>
</cp:coreProperties>
</file>